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4676"/>
  </p:normalViewPr>
  <p:slideViewPr>
    <p:cSldViewPr snapToGrid="0" snapToObjects="1">
      <p:cViewPr varScale="1">
        <p:scale>
          <a:sx n="108" d="100"/>
          <a:sy n="108" d="100"/>
        </p:scale>
        <p:origin x="36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8647231-A442-1247-9251-FB56BDA07FD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AFA4B524-CEC7-2945-BA0B-C6D1224123B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FDBE5CD-5703-114D-BD9C-19F571FEC7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B9ABCCF-A651-F346-B902-88DA280E9A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33F96567-2446-DB41-AE56-A9A67614CA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0251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F911EAA6-5D76-9341-AFEB-B35B9F76AD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A21C84FC-911F-6043-8FDE-DC44652C5D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F7F1972-5B2E-AA49-A7D7-BC23677C8D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0AB8A4C-2AFF-5942-BBF7-A2CF7E181D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13C9DD4-B27C-DC4F-BC22-CB8A664EA0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797384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BD6597D7-48B7-9C48-AAC6-5692A1CFC5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CA54F3B-115A-6449-8C8B-BEC189F15F0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F383FD8-EDE8-5A4A-A4B6-BB1086708B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35E3335F-A8F0-1142-8283-93240784A4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06C2E637-BD94-7145-986A-178A67A73C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543596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5A80769-4884-9C4B-89CD-A82E4FFED6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3AAD4514-3E06-EF4A-A53A-3B86E67810F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F93497A-2606-EE44-B24C-02E14746C7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DDED17F-9573-CD45-BAE9-E015B744B7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E38C5D7-AD22-084E-A505-500BA4997F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013300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EF89DB5-6152-7948-B3C9-F5E8BB77A8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E0CC3CF-BB4A-DE4A-86F6-7EF026CE1A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38CB9582-713D-9746-9DE5-0345036775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4F27BCB-D505-B944-B0BC-62A25BF128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9A7B555-F3B3-7A43-8DC8-6DC7FDC644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64767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A4C1766-D65A-AC46-B090-393AF9561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B2E0E428-82CB-1946-A489-5ACD91B37C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3B2D36A2-AA74-5F43-A14E-3CE6C076A5A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A7B0981A-91E1-664A-921C-113A986BD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7F308F9-3FA1-D349-B38B-1D7478E8E9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C6D7E782-F24B-CE40-BF11-13AE48023A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58425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BAB171D-EA3D-9448-8D2C-B669C9032F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A8B240D2-1A9E-4647-996F-13FE518A6E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83A520E3-8FAF-F04C-A7F3-D42F4009A9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6FB51302-76DC-B440-9478-5CB8259B82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49E31E7B-9C18-CD49-961C-4A384338E21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13AA98CE-FD7C-1449-86BB-FF9908B8C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BF347AD-D6F5-0F4A-88AE-BFBF7624E9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BFC6A41C-2E9F-FE47-9945-36B1D3A512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9052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BE3D89D-AAF8-2F4D-8B11-177A52E66F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21A61610-1DB4-5449-8874-CF2018428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223A800-6ACE-6242-ABEA-C0CE99CDE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EEA00D7-5BCE-5645-9707-AD606F1CEC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369594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59CD041F-2AC0-7640-939C-8FC308DC8F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31CCCA0-719E-4F44-B616-048DC31E32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2B61E8A0-123E-6F4D-9423-E6901CB613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29488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4990584-116E-D741-817E-621315B10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C7B50F75-4597-2349-909D-DDE54B61A7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193E077-BF48-054E-B98B-AFCD92B2ABD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63FFF6B6-51DA-0A42-81D2-FC3EA6959B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3FD7E406-2B85-6946-9BA0-EE8E05BE6B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82E089A-1CB1-6D4C-A6A6-85D77EEA30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20960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1559ADF-A7A4-DD45-9419-6D8259DCB9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8F3020C6-BDF3-B847-9278-24079D6C4A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80FAD32-CF3F-9649-914D-33D12D75B38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609E02C-FF2A-FB48-83D0-5ED13B2914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2F81E41E-81EC-3D4F-97E7-EC649916BD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7DAF5350-318A-A04A-9A82-7FE0A944B1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673728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3F6855FA-9244-3045-AD73-8329783260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D4DD0EB1-C5AA-FF46-8A8C-A7742B4F54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B37CA0B-8D75-2240-9675-62A3CFFC055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06BC71-271F-4F46-8FD7-9A305CA96614}" type="datetimeFigureOut">
              <a:rPr lang="it-IT" smtClean="0"/>
              <a:t>26/12/2021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5B691207-B755-7B42-9CED-6F57087661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C03EC9E-9443-F943-8A8F-C5701AF9E0D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A5CF99-B414-224A-9E8A-6DAECEF86F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345701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 descr="Immagine che contiene disegnando&#10;&#10;Descrizione generata automaticamente">
            <a:extLst>
              <a:ext uri="{FF2B5EF4-FFF2-40B4-BE49-F238E27FC236}">
                <a16:creationId xmlns:a16="http://schemas.microsoft.com/office/drawing/2014/main" id="{8EB72F84-486D-0B46-89C4-A5F6E4436A7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990" t="6204" r="3051" b="14924"/>
          <a:stretch/>
        </p:blipFill>
        <p:spPr>
          <a:xfrm>
            <a:off x="3086100" y="1028699"/>
            <a:ext cx="5657850" cy="4800601"/>
          </a:xfrm>
          <a:prstGeom prst="rect">
            <a:avLst/>
          </a:prstGeom>
        </p:spPr>
      </p:pic>
      <p:sp>
        <p:nvSpPr>
          <p:cNvPr id="2" name="Rettangolo 1">
            <a:extLst>
              <a:ext uri="{FF2B5EF4-FFF2-40B4-BE49-F238E27FC236}">
                <a16:creationId xmlns:a16="http://schemas.microsoft.com/office/drawing/2014/main" id="{1F2F32E5-AA6C-6649-BDBA-D4E467CE8A81}"/>
              </a:ext>
            </a:extLst>
          </p:cNvPr>
          <p:cNvSpPr/>
          <p:nvPr/>
        </p:nvSpPr>
        <p:spPr>
          <a:xfrm>
            <a:off x="4165380" y="965995"/>
            <a:ext cx="956441" cy="525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5" name="Rettangolo 4">
            <a:extLst>
              <a:ext uri="{FF2B5EF4-FFF2-40B4-BE49-F238E27FC236}">
                <a16:creationId xmlns:a16="http://schemas.microsoft.com/office/drawing/2014/main" id="{1E991357-C5D1-7542-929B-88EFE4CEE757}"/>
              </a:ext>
            </a:extLst>
          </p:cNvPr>
          <p:cNvSpPr/>
          <p:nvPr/>
        </p:nvSpPr>
        <p:spPr>
          <a:xfrm>
            <a:off x="6201101" y="996971"/>
            <a:ext cx="1825521" cy="525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3" name="CasellaDiTesto 2">
            <a:extLst>
              <a:ext uri="{FF2B5EF4-FFF2-40B4-BE49-F238E27FC236}">
                <a16:creationId xmlns:a16="http://schemas.microsoft.com/office/drawing/2014/main" id="{46A62119-EA3F-674F-927D-5CD69C8AA9AC}"/>
              </a:ext>
            </a:extLst>
          </p:cNvPr>
          <p:cNvSpPr txBox="1"/>
          <p:nvPr/>
        </p:nvSpPr>
        <p:spPr>
          <a:xfrm>
            <a:off x="4243551" y="1068407"/>
            <a:ext cx="8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Arial" panose="020B0604020202020204" pitchFamily="34" charset="0"/>
              </a:rPr>
              <a:t>PAP</a:t>
            </a:r>
          </a:p>
        </p:txBody>
      </p:sp>
      <p:sp>
        <p:nvSpPr>
          <p:cNvPr id="8" name="Rettangolo 7">
            <a:extLst>
              <a:ext uri="{FF2B5EF4-FFF2-40B4-BE49-F238E27FC236}">
                <a16:creationId xmlns:a16="http://schemas.microsoft.com/office/drawing/2014/main" id="{279BADD3-E137-9E41-867A-CF00966B33C9}"/>
              </a:ext>
            </a:extLst>
          </p:cNvPr>
          <p:cNvSpPr/>
          <p:nvPr/>
        </p:nvSpPr>
        <p:spPr>
          <a:xfrm>
            <a:off x="7113861" y="5374500"/>
            <a:ext cx="1825521" cy="525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9" name="CasellaDiTesto 8">
            <a:extLst>
              <a:ext uri="{FF2B5EF4-FFF2-40B4-BE49-F238E27FC236}">
                <a16:creationId xmlns:a16="http://schemas.microsoft.com/office/drawing/2014/main" id="{4354FD73-F036-914E-8D84-59B79E91AC38}"/>
              </a:ext>
            </a:extLst>
          </p:cNvPr>
          <p:cNvSpPr txBox="1"/>
          <p:nvPr/>
        </p:nvSpPr>
        <p:spPr>
          <a:xfrm>
            <a:off x="6924188" y="1059674"/>
            <a:ext cx="8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Arial" panose="020B0604020202020204" pitchFamily="34" charset="0"/>
              </a:rPr>
              <a:t>SIG</a:t>
            </a:r>
          </a:p>
        </p:txBody>
      </p:sp>
      <p:sp>
        <p:nvSpPr>
          <p:cNvPr id="10" name="CasellaDiTesto 9">
            <a:extLst>
              <a:ext uri="{FF2B5EF4-FFF2-40B4-BE49-F238E27FC236}">
                <a16:creationId xmlns:a16="http://schemas.microsoft.com/office/drawing/2014/main" id="{8DC99C1D-449D-234B-8151-0CDBCF7A949B}"/>
              </a:ext>
            </a:extLst>
          </p:cNvPr>
          <p:cNvSpPr txBox="1"/>
          <p:nvPr/>
        </p:nvSpPr>
        <p:spPr>
          <a:xfrm>
            <a:off x="8539332" y="3555224"/>
            <a:ext cx="8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Arial" panose="020B0604020202020204" pitchFamily="34" charset="0"/>
              </a:rPr>
              <a:t>CIL</a:t>
            </a:r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739A346E-0395-494E-9641-6BE26AB6032A}"/>
              </a:ext>
            </a:extLst>
          </p:cNvPr>
          <p:cNvSpPr/>
          <p:nvPr/>
        </p:nvSpPr>
        <p:spPr>
          <a:xfrm>
            <a:off x="3314700" y="5217337"/>
            <a:ext cx="1085850" cy="52551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 dirty="0"/>
          </a:p>
        </p:txBody>
      </p:sp>
      <p:sp>
        <p:nvSpPr>
          <p:cNvPr id="12" name="CasellaDiTesto 11">
            <a:extLst>
              <a:ext uri="{FF2B5EF4-FFF2-40B4-BE49-F238E27FC236}">
                <a16:creationId xmlns:a16="http://schemas.microsoft.com/office/drawing/2014/main" id="{C7923E96-F892-E345-B41A-02B38EB460DB}"/>
              </a:ext>
            </a:extLst>
          </p:cNvPr>
          <p:cNvSpPr txBox="1"/>
          <p:nvPr/>
        </p:nvSpPr>
        <p:spPr>
          <a:xfrm>
            <a:off x="2501130" y="3555224"/>
            <a:ext cx="800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2400" dirty="0">
                <a:latin typeface="Calibri "/>
                <a:cs typeface="Arial" panose="020B0604020202020204" pitchFamily="34" charset="0"/>
              </a:rPr>
              <a:t>CDT</a:t>
            </a:r>
          </a:p>
        </p:txBody>
      </p:sp>
      <p:sp>
        <p:nvSpPr>
          <p:cNvPr id="14" name="CasellaDiTesto 13">
            <a:extLst>
              <a:ext uri="{FF2B5EF4-FFF2-40B4-BE49-F238E27FC236}">
                <a16:creationId xmlns:a16="http://schemas.microsoft.com/office/drawing/2014/main" id="{32AE7E22-9CA9-45D9-9103-C363B1CF8D28}"/>
              </a:ext>
            </a:extLst>
          </p:cNvPr>
          <p:cNvSpPr txBox="1"/>
          <p:nvPr/>
        </p:nvSpPr>
        <p:spPr>
          <a:xfrm>
            <a:off x="1755518" y="6285724"/>
            <a:ext cx="868096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cs typeface="Times New Roman" panose="02020603050405020304" pitchFamily="18" charset="0"/>
              </a:rPr>
              <a:t>Figure S2: </a:t>
            </a:r>
            <a:r>
              <a:rPr lang="en-US" sz="1200" dirty="0">
                <a:cs typeface="Times New Roman" panose="02020603050405020304" pitchFamily="18" charset="0"/>
              </a:rPr>
              <a:t>Number of </a:t>
            </a:r>
            <a:r>
              <a:rPr lang="en-US" sz="1200" i="1" dirty="0">
                <a:cs typeface="Times New Roman" panose="02020603050405020304" pitchFamily="18" charset="0"/>
              </a:rPr>
              <a:t>de novo</a:t>
            </a:r>
            <a:r>
              <a:rPr lang="en-US" sz="1200" dirty="0">
                <a:cs typeface="Times New Roman" panose="02020603050405020304" pitchFamily="18" charset="0"/>
              </a:rPr>
              <a:t> assembled scaffolds in CDT, PAP, SIG and CIL, respectively. The number of common scaffolds is also shown.</a:t>
            </a:r>
          </a:p>
        </p:txBody>
      </p:sp>
    </p:spTree>
    <p:extLst>
      <p:ext uri="{BB962C8B-B14F-4D97-AF65-F5344CB8AC3E}">
        <p14:creationId xmlns:p14="http://schemas.microsoft.com/office/powerpoint/2010/main" val="253706138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33</Words>
  <Application>Microsoft Office PowerPoint</Application>
  <PresentationFormat>Widescreen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</vt:lpstr>
      <vt:lpstr>Calibri Light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salvatore esposito</dc:creator>
  <cp:lastModifiedBy>pasquale tripodi</cp:lastModifiedBy>
  <cp:revision>8</cp:revision>
  <dcterms:created xsi:type="dcterms:W3CDTF">2020-08-28T08:02:35Z</dcterms:created>
  <dcterms:modified xsi:type="dcterms:W3CDTF">2021-12-26T14:42:27Z</dcterms:modified>
</cp:coreProperties>
</file>